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02E3D1C-8413-C168-C29C-1B92782DB34B}"/>
              </a:ext>
            </a:extLst>
          </p:cNvPr>
          <p:cNvSpPr txBox="1"/>
          <p:nvPr/>
        </p:nvSpPr>
        <p:spPr>
          <a:xfrm>
            <a:off x="6694893" y="1432922"/>
            <a:ext cx="4824000" cy="39301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5.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replicate used for the quantification in Figure 2b. Wells A and B contain non-floated PC:NTA-Ni and PC:PE:NTA-Ni liposomes incubated with HR1-His peptides. Wells G and H contain the corresponding floated samples. Wells C and D contain non-floated PC:MAL and PC:PE:MAL liposomes incubated with HR1-Cys peptides. Wells I and J contain the corresponding floated samples. The remaining wells contain other samples that are not relevant to the figures presented in the manuscript.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417" y="872731"/>
            <a:ext cx="5901835" cy="5050498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427747" y="3766550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778271" y="3766550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128795" y="3766550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479319" y="3766549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829843" y="3766549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180366" y="376654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779222" y="376654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141691" y="376654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512181" y="376654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818503" y="3766547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5164930" y="376654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5511357" y="3766545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27812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105</Words>
  <Application>Microsoft Office PowerPoint</Application>
  <PresentationFormat>Grand écran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1</cp:revision>
  <dcterms:created xsi:type="dcterms:W3CDTF">2023-08-01T09:01:08Z</dcterms:created>
  <dcterms:modified xsi:type="dcterms:W3CDTF">2023-08-02T09:12:19Z</dcterms:modified>
</cp:coreProperties>
</file>